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13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385869-AAF5-4503-8CBA-5A53B75F2646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D24FFE-BFEA-4A39-B43E-3AC724A279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7959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23" name="Google Shape;12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555559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9259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7548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6939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0193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9192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3626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509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570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8403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693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6931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B1DB7-C1C7-4624-8908-DCDCF6DF2FC2}" type="datetimeFigureOut">
              <a:rPr lang="it-IT" smtClean="0"/>
              <a:t>09/10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CD25C-0F01-44FE-B5F9-A8DED31AA1C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5539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16"/>
          <p:cNvSpPr/>
          <p:nvPr/>
        </p:nvSpPr>
        <p:spPr>
          <a:xfrm>
            <a:off x="7878183" y="2642421"/>
            <a:ext cx="1177771" cy="1783317"/>
          </a:xfrm>
          <a:prstGeom prst="rect">
            <a:avLst/>
          </a:prstGeom>
          <a:solidFill>
            <a:schemeClr val="lt1">
              <a:alpha val="36862"/>
            </a:schemeClr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26" name="Google Shape;126;p16"/>
          <p:cNvGrpSpPr/>
          <p:nvPr/>
        </p:nvGrpSpPr>
        <p:grpSpPr>
          <a:xfrm>
            <a:off x="718056" y="1855642"/>
            <a:ext cx="3364397" cy="3742085"/>
            <a:chOff x="530087" y="1325217"/>
            <a:chExt cx="4485863" cy="4989447"/>
          </a:xfrm>
        </p:grpSpPr>
        <p:sp>
          <p:nvSpPr>
            <p:cNvPr id="127" name="Google Shape;127;p16"/>
            <p:cNvSpPr/>
            <p:nvPr/>
          </p:nvSpPr>
          <p:spPr>
            <a:xfrm>
              <a:off x="530087" y="1325217"/>
              <a:ext cx="4479235" cy="2491409"/>
            </a:xfrm>
            <a:prstGeom prst="ellipse">
              <a:avLst/>
            </a:prstGeom>
            <a:solidFill>
              <a:schemeClr val="lt1"/>
            </a:solidFill>
            <a:ln w="28575" cap="flat" cmpd="sng">
              <a:solidFill>
                <a:srgbClr val="0D567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50800" dist="38100" dir="10800000" algn="r" rotWithShape="0">
                <a:schemeClr val="dk1">
                  <a:alpha val="40000"/>
                </a:schemeClr>
              </a:outerShdw>
            </a:effectLst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r>
                <a:rPr lang="it-IT" sz="135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GJ</a:t>
              </a: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28" name="Google Shape;128;p16"/>
            <p:cNvSpPr/>
            <p:nvPr/>
          </p:nvSpPr>
          <p:spPr>
            <a:xfrm>
              <a:off x="536715" y="3823255"/>
              <a:ext cx="4479235" cy="2491409"/>
            </a:xfrm>
            <a:prstGeom prst="ellipse">
              <a:avLst/>
            </a:prstGeom>
            <a:solidFill>
              <a:schemeClr val="lt1"/>
            </a:solidFill>
            <a:ln w="28575" cap="flat" cmpd="sng">
              <a:solidFill>
                <a:srgbClr val="0D567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50800" dist="38100" dir="8100000" algn="tr" rotWithShape="0">
                <a:srgbClr val="000000">
                  <a:alpha val="40000"/>
                </a:srgbClr>
              </a:outerShdw>
            </a:effectLst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29" name="Google Shape;129;p16"/>
          <p:cNvSpPr txBox="1"/>
          <p:nvPr/>
        </p:nvSpPr>
        <p:spPr>
          <a:xfrm>
            <a:off x="705529" y="1028777"/>
            <a:ext cx="3376924" cy="3923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>
              <a:buClr>
                <a:srgbClr val="000000"/>
              </a:buClr>
              <a:buSzPts val="2400"/>
            </a:pPr>
            <a:r>
              <a:rPr lang="it-IT" b="1">
                <a:solidFill>
                  <a:srgbClr val="264457"/>
                </a:solidFill>
                <a:latin typeface="Calibri"/>
                <a:ea typeface="Calibri"/>
                <a:cs typeface="Calibri"/>
                <a:sym typeface="Calibri"/>
              </a:rPr>
              <a:t>SHORT TERM REGULATION (&lt;3h)</a:t>
            </a:r>
            <a:endParaRPr b="1">
              <a:solidFill>
                <a:srgbClr val="264457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0" name="Google Shape;130;p16"/>
          <p:cNvSpPr txBox="1"/>
          <p:nvPr/>
        </p:nvSpPr>
        <p:spPr>
          <a:xfrm>
            <a:off x="3988361" y="1037106"/>
            <a:ext cx="5024343" cy="4999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it-IT" b="1">
                <a:solidFill>
                  <a:srgbClr val="264457"/>
                </a:solidFill>
                <a:latin typeface="Calibri"/>
                <a:ea typeface="Calibri"/>
                <a:cs typeface="Calibri"/>
                <a:sym typeface="Calibri"/>
              </a:rPr>
              <a:t>LONG TERM REGULATION (&gt;3h)</a:t>
            </a:r>
            <a:endParaRPr b="1">
              <a:solidFill>
                <a:srgbClr val="264457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algn="ctr"/>
            <a:endParaRPr sz="105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1" name="Google Shape;131;p16"/>
          <p:cNvSpPr txBox="1"/>
          <p:nvPr/>
        </p:nvSpPr>
        <p:spPr>
          <a:xfrm>
            <a:off x="2335661" y="1888616"/>
            <a:ext cx="57405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erK</a:t>
            </a:r>
            <a:endParaRPr sz="135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2" name="Google Shape;132;p16"/>
          <p:cNvSpPr txBox="1"/>
          <p:nvPr/>
        </p:nvSpPr>
        <p:spPr>
          <a:xfrm>
            <a:off x="2685523" y="2904043"/>
            <a:ext cx="64571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1P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3" name="Google Shape;133;p16"/>
          <p:cNvSpPr txBox="1"/>
          <p:nvPr/>
        </p:nvSpPr>
        <p:spPr>
          <a:xfrm>
            <a:off x="1610889" y="1903748"/>
            <a:ext cx="54864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1P</a:t>
            </a:r>
            <a:endParaRPr sz="135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34" name="Google Shape;134;p16"/>
          <p:cNvGrpSpPr/>
          <p:nvPr/>
        </p:nvGrpSpPr>
        <p:grpSpPr>
          <a:xfrm>
            <a:off x="3262659" y="1637405"/>
            <a:ext cx="917975" cy="276999"/>
            <a:chOff x="3559126" y="1111350"/>
            <a:chExt cx="1223967" cy="369332"/>
          </a:xfrm>
        </p:grpSpPr>
        <p:sp>
          <p:nvSpPr>
            <p:cNvPr id="135" name="Google Shape;135;p16"/>
            <p:cNvSpPr txBox="1"/>
            <p:nvPr/>
          </p:nvSpPr>
          <p:spPr>
            <a:xfrm>
              <a:off x="3615474" y="1111350"/>
              <a:ext cx="1167619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69" tIns="34275" rIns="68569" bIns="34275" anchor="t" anchorCtr="0">
              <a:noAutofit/>
            </a:bodyPr>
            <a:lstStyle/>
            <a:p>
              <a:pPr>
                <a:buClr>
                  <a:srgbClr val="000000"/>
                </a:buClr>
                <a:buSzPts val="1800"/>
              </a:pPr>
              <a:r>
                <a:rPr lang="it-IT" sz="1350" b="1">
                  <a:solidFill>
                    <a:srgbClr val="1E4429"/>
                  </a:solidFill>
                  <a:latin typeface="Calibri"/>
                  <a:ea typeface="Calibri"/>
                  <a:cs typeface="Calibri"/>
                  <a:sym typeface="Calibri"/>
                </a:rPr>
                <a:t>PCB153</a:t>
              </a:r>
              <a:endParaRPr sz="1350" b="1">
                <a:solidFill>
                  <a:srgbClr val="1E4429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6" name="Google Shape;136;p16"/>
            <p:cNvSpPr/>
            <p:nvPr/>
          </p:nvSpPr>
          <p:spPr>
            <a:xfrm>
              <a:off x="3559126" y="1111350"/>
              <a:ext cx="1039383" cy="369332"/>
            </a:xfrm>
            <a:prstGeom prst="rect">
              <a:avLst/>
            </a:prstGeom>
            <a:noFill/>
            <a:ln w="25400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37" name="Google Shape;137;p16"/>
          <p:cNvSpPr/>
          <p:nvPr/>
        </p:nvSpPr>
        <p:spPr>
          <a:xfrm rot="2311501">
            <a:off x="2158778" y="2052811"/>
            <a:ext cx="240255" cy="289607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8" name="Google Shape;138;p16"/>
          <p:cNvSpPr/>
          <p:nvPr/>
        </p:nvSpPr>
        <p:spPr>
          <a:xfrm rot="-305100">
            <a:off x="2871841" y="2478701"/>
            <a:ext cx="67868" cy="442091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9" name="Google Shape;139;p16"/>
          <p:cNvSpPr txBox="1"/>
          <p:nvPr/>
        </p:nvSpPr>
        <p:spPr>
          <a:xfrm>
            <a:off x="1760896" y="2804441"/>
            <a:ext cx="1147634" cy="4630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800"/>
            </a:pPr>
            <a:r>
              <a:rPr lang="it-IT" sz="21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P2A</a:t>
            </a:r>
            <a:endParaRPr sz="21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0" name="Google Shape;140;p16"/>
          <p:cNvSpPr/>
          <p:nvPr/>
        </p:nvSpPr>
        <p:spPr>
          <a:xfrm rot="5042149">
            <a:off x="2107439" y="1917064"/>
            <a:ext cx="69094" cy="230369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1" name="Google Shape;141;p16"/>
          <p:cNvSpPr txBox="1"/>
          <p:nvPr/>
        </p:nvSpPr>
        <p:spPr>
          <a:xfrm>
            <a:off x="2933089" y="2517650"/>
            <a:ext cx="70239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hK1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2" name="Google Shape;142;p16" descr="C:\Users\eglantina\Desktop\lavoro Meacci\wp-1474396855108.jpg"/>
          <p:cNvPicPr preferRelativeResize="0"/>
          <p:nvPr/>
        </p:nvPicPr>
        <p:blipFill rotWithShape="1">
          <a:blip r:embed="rId3">
            <a:alphaModFix/>
          </a:blip>
          <a:srcRect l="30075" t="12236" r="28900" b="67403"/>
          <a:stretch/>
        </p:blipFill>
        <p:spPr>
          <a:xfrm rot="5400000">
            <a:off x="2016505" y="3489752"/>
            <a:ext cx="660848" cy="417177"/>
          </a:xfrm>
          <a:prstGeom prst="rect">
            <a:avLst/>
          </a:prstGeom>
          <a:noFill/>
          <a:ln>
            <a:noFill/>
          </a:ln>
        </p:spPr>
      </p:pic>
      <p:sp>
        <p:nvSpPr>
          <p:cNvPr id="143" name="Google Shape;143;p16"/>
          <p:cNvSpPr/>
          <p:nvPr/>
        </p:nvSpPr>
        <p:spPr>
          <a:xfrm rot="10800000">
            <a:off x="2143630" y="4040887"/>
            <a:ext cx="179429" cy="238316"/>
          </a:xfrm>
          <a:prstGeom prst="up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9050" cap="rnd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44" name="Google Shape;144;p16"/>
          <p:cNvGrpSpPr/>
          <p:nvPr/>
        </p:nvGrpSpPr>
        <p:grpSpPr>
          <a:xfrm>
            <a:off x="4440542" y="1858129"/>
            <a:ext cx="3364397" cy="3742085"/>
            <a:chOff x="530087" y="1325217"/>
            <a:chExt cx="4485863" cy="4989447"/>
          </a:xfrm>
        </p:grpSpPr>
        <p:sp>
          <p:nvSpPr>
            <p:cNvPr id="145" name="Google Shape;145;p16"/>
            <p:cNvSpPr/>
            <p:nvPr/>
          </p:nvSpPr>
          <p:spPr>
            <a:xfrm>
              <a:off x="530087" y="1325217"/>
              <a:ext cx="4479235" cy="2491409"/>
            </a:xfrm>
            <a:prstGeom prst="ellipse">
              <a:avLst/>
            </a:prstGeom>
            <a:solidFill>
              <a:schemeClr val="lt1"/>
            </a:solidFill>
            <a:ln w="28575" cap="flat" cmpd="sng">
              <a:solidFill>
                <a:srgbClr val="0D567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50800" dist="38100" dir="10800000" algn="r" rotWithShape="0">
                <a:schemeClr val="dk1">
                  <a:alpha val="40000"/>
                </a:schemeClr>
              </a:outerShdw>
            </a:effectLst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6" name="Google Shape;146;p16"/>
            <p:cNvSpPr/>
            <p:nvPr/>
          </p:nvSpPr>
          <p:spPr>
            <a:xfrm>
              <a:off x="536715" y="3823255"/>
              <a:ext cx="4479235" cy="2491409"/>
            </a:xfrm>
            <a:prstGeom prst="ellipse">
              <a:avLst/>
            </a:prstGeom>
            <a:solidFill>
              <a:schemeClr val="lt1"/>
            </a:solidFill>
            <a:ln w="28575" cap="flat" cmpd="sng">
              <a:solidFill>
                <a:srgbClr val="0D567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50800" dist="38100" dir="8100000" algn="tr" rotWithShape="0">
                <a:srgbClr val="000000">
                  <a:alpha val="40000"/>
                </a:srgbClr>
              </a:outerShdw>
            </a:effectLst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47" name="Google Shape;147;p16"/>
          <p:cNvSpPr txBox="1"/>
          <p:nvPr/>
        </p:nvSpPr>
        <p:spPr>
          <a:xfrm>
            <a:off x="6219645" y="1755649"/>
            <a:ext cx="57405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it-IT" sz="13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</a:t>
            </a: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erK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8" name="Google Shape;148;p16"/>
          <p:cNvSpPr txBox="1"/>
          <p:nvPr/>
        </p:nvSpPr>
        <p:spPr>
          <a:xfrm>
            <a:off x="5029418" y="1879286"/>
            <a:ext cx="92706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it-IT" sz="13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  </a:t>
            </a:r>
            <a:r>
              <a:rPr lang="it-IT" sz="3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1P</a:t>
            </a:r>
            <a:endParaRPr sz="3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49" name="Google Shape;149;p16"/>
          <p:cNvGrpSpPr/>
          <p:nvPr/>
        </p:nvGrpSpPr>
        <p:grpSpPr>
          <a:xfrm>
            <a:off x="7246048" y="1760847"/>
            <a:ext cx="936719" cy="299173"/>
            <a:chOff x="3559126" y="1081785"/>
            <a:chExt cx="1248959" cy="398897"/>
          </a:xfrm>
        </p:grpSpPr>
        <p:sp>
          <p:nvSpPr>
            <p:cNvPr id="150" name="Google Shape;150;p16"/>
            <p:cNvSpPr txBox="1"/>
            <p:nvPr/>
          </p:nvSpPr>
          <p:spPr>
            <a:xfrm>
              <a:off x="3640466" y="1081785"/>
              <a:ext cx="1167619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69" tIns="34275" rIns="68569" bIns="34275" anchor="t" anchorCtr="0">
              <a:noAutofit/>
            </a:bodyPr>
            <a:lstStyle/>
            <a:p>
              <a:pPr>
                <a:buClr>
                  <a:srgbClr val="000000"/>
                </a:buClr>
                <a:buSzPts val="1800"/>
              </a:pPr>
              <a:r>
                <a:rPr lang="it-IT" sz="1350" b="1">
                  <a:solidFill>
                    <a:srgbClr val="1E4429"/>
                  </a:solidFill>
                  <a:latin typeface="Calibri"/>
                  <a:ea typeface="Calibri"/>
                  <a:cs typeface="Calibri"/>
                  <a:sym typeface="Calibri"/>
                </a:rPr>
                <a:t>PCB153</a:t>
              </a:r>
              <a:endParaRPr sz="1350" b="1">
                <a:solidFill>
                  <a:srgbClr val="1E4429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51" name="Google Shape;151;p16"/>
            <p:cNvSpPr/>
            <p:nvPr/>
          </p:nvSpPr>
          <p:spPr>
            <a:xfrm>
              <a:off x="3559126" y="1111350"/>
              <a:ext cx="1039383" cy="369332"/>
            </a:xfrm>
            <a:prstGeom prst="rect">
              <a:avLst/>
            </a:prstGeom>
            <a:noFill/>
            <a:ln w="25400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68569" tIns="34275" rIns="68569" bIns="34275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 sz="135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52" name="Google Shape;152;p16"/>
          <p:cNvSpPr/>
          <p:nvPr/>
        </p:nvSpPr>
        <p:spPr>
          <a:xfrm rot="2311501">
            <a:off x="6079458" y="2246194"/>
            <a:ext cx="83698" cy="22847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3" name="Google Shape;153;p16"/>
          <p:cNvSpPr txBox="1"/>
          <p:nvPr/>
        </p:nvSpPr>
        <p:spPr>
          <a:xfrm>
            <a:off x="5451775" y="2780573"/>
            <a:ext cx="74639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P2A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4" name="Google Shape;154;p16"/>
          <p:cNvSpPr txBox="1"/>
          <p:nvPr/>
        </p:nvSpPr>
        <p:spPr>
          <a:xfrm>
            <a:off x="6100608" y="4120819"/>
            <a:ext cx="1657055" cy="4847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350" b="1">
                <a:solidFill>
                  <a:srgbClr val="124163"/>
                </a:solidFill>
                <a:latin typeface="Calibri"/>
                <a:ea typeface="Calibri"/>
                <a:cs typeface="Calibri"/>
                <a:sym typeface="Calibri"/>
              </a:rPr>
              <a:t>Voltage-dependent </a:t>
            </a:r>
            <a:endParaRPr sz="1350" b="1">
              <a:solidFill>
                <a:srgbClr val="124163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5" name="Google Shape;155;p16"/>
          <p:cNvSpPr/>
          <p:nvPr/>
        </p:nvSpPr>
        <p:spPr>
          <a:xfrm flipH="1">
            <a:off x="5783861" y="3038907"/>
            <a:ext cx="34289" cy="26517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6" name="Google Shape;156;p16" descr="C:\Users\eglantina\Desktop\lavoro Meacci\wp-1474396855108.jpg"/>
          <p:cNvPicPr preferRelativeResize="0"/>
          <p:nvPr/>
        </p:nvPicPr>
        <p:blipFill rotWithShape="1">
          <a:blip r:embed="rId3">
            <a:alphaModFix/>
          </a:blip>
          <a:srcRect l="30075" t="12236" r="28900" b="67403"/>
          <a:stretch/>
        </p:blipFill>
        <p:spPr>
          <a:xfrm rot="5400000">
            <a:off x="5683333" y="3549797"/>
            <a:ext cx="660848" cy="417177"/>
          </a:xfrm>
          <a:prstGeom prst="rect">
            <a:avLst/>
          </a:prstGeom>
          <a:noFill/>
          <a:ln>
            <a:noFill/>
          </a:ln>
        </p:spPr>
      </p:pic>
      <p:sp>
        <p:nvSpPr>
          <p:cNvPr id="157" name="Google Shape;157;p16"/>
          <p:cNvSpPr/>
          <p:nvPr/>
        </p:nvSpPr>
        <p:spPr>
          <a:xfrm rot="10800000" flipH="1">
            <a:off x="5975000" y="4139379"/>
            <a:ext cx="77513" cy="256841"/>
          </a:xfrm>
          <a:prstGeom prst="up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9050" cap="rnd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8" name="Google Shape;158;p16"/>
          <p:cNvSpPr/>
          <p:nvPr/>
        </p:nvSpPr>
        <p:spPr>
          <a:xfrm>
            <a:off x="1361662" y="4782397"/>
            <a:ext cx="2133674" cy="5309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CB153 mainly directed to  Cx43-formed GJ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9" name="Google Shape;159;p16"/>
          <p:cNvSpPr/>
          <p:nvPr/>
        </p:nvSpPr>
        <p:spPr>
          <a:xfrm>
            <a:off x="4959147" y="4803140"/>
            <a:ext cx="2471391" cy="5309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 algn="ctr"/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CB153 mainly directed to  Cx32- and Cx26-formed GJ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0" name="Google Shape;160;p16"/>
          <p:cNvSpPr/>
          <p:nvPr/>
        </p:nvSpPr>
        <p:spPr>
          <a:xfrm rot="6457548">
            <a:off x="2848878" y="1656340"/>
            <a:ext cx="319001" cy="362913"/>
          </a:xfrm>
          <a:prstGeom prst="lightningBolt">
            <a:avLst/>
          </a:prstGeom>
          <a:solidFill>
            <a:srgbClr val="FFFF00"/>
          </a:solidFill>
          <a:ln w="25400" cap="flat" cmpd="sng">
            <a:solidFill>
              <a:srgbClr val="FFC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1" name="Google Shape;161;p16"/>
          <p:cNvSpPr/>
          <p:nvPr/>
        </p:nvSpPr>
        <p:spPr>
          <a:xfrm rot="6457548">
            <a:off x="6748232" y="1774147"/>
            <a:ext cx="371678" cy="411574"/>
          </a:xfrm>
          <a:prstGeom prst="lightningBolt">
            <a:avLst/>
          </a:prstGeom>
          <a:solidFill>
            <a:srgbClr val="FFFF00"/>
          </a:solidFill>
          <a:ln w="25400" cap="flat" cmpd="sng">
            <a:solidFill>
              <a:srgbClr val="FFC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2" name="Google Shape;162;p16"/>
          <p:cNvSpPr txBox="1"/>
          <p:nvPr/>
        </p:nvSpPr>
        <p:spPr>
          <a:xfrm>
            <a:off x="372143" y="3531815"/>
            <a:ext cx="1761748" cy="346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GJ inhibition</a:t>
            </a:r>
            <a:endParaRPr b="1">
              <a:solidFill>
                <a:srgbClr val="FF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3" name="Google Shape;163;p16"/>
          <p:cNvSpPr/>
          <p:nvPr/>
        </p:nvSpPr>
        <p:spPr>
          <a:xfrm rot="10800000">
            <a:off x="8031605" y="3821639"/>
            <a:ext cx="136158" cy="256404"/>
          </a:xfrm>
          <a:prstGeom prst="up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9050" cap="rnd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4" name="Google Shape;164;p16"/>
          <p:cNvSpPr/>
          <p:nvPr/>
        </p:nvSpPr>
        <p:spPr>
          <a:xfrm>
            <a:off x="8189379" y="3763451"/>
            <a:ext cx="1079803" cy="3924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0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creased expression</a:t>
            </a:r>
            <a:endParaRPr sz="105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5" name="Google Shape;165;p16"/>
          <p:cNvSpPr/>
          <p:nvPr/>
        </p:nvSpPr>
        <p:spPr>
          <a:xfrm>
            <a:off x="8011171" y="2842165"/>
            <a:ext cx="76769" cy="29852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6" name="Google Shape;166;p16"/>
          <p:cNvSpPr/>
          <p:nvPr/>
        </p:nvSpPr>
        <p:spPr>
          <a:xfrm>
            <a:off x="8114170" y="2830574"/>
            <a:ext cx="999312" cy="230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0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ctivation path</a:t>
            </a:r>
            <a:endParaRPr sz="105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7" name="Google Shape;167;p16"/>
          <p:cNvSpPr/>
          <p:nvPr/>
        </p:nvSpPr>
        <p:spPr>
          <a:xfrm>
            <a:off x="7923476" y="3616382"/>
            <a:ext cx="265902" cy="51141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8" name="Google Shape;168;p16"/>
          <p:cNvSpPr/>
          <p:nvPr/>
        </p:nvSpPr>
        <p:spPr>
          <a:xfrm rot="5400000">
            <a:off x="7880896" y="3436342"/>
            <a:ext cx="351065" cy="3989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r>
              <a:rPr lang="it-IT" sz="135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</a:t>
            </a: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9" name="Google Shape;169;p16"/>
          <p:cNvSpPr/>
          <p:nvPr/>
        </p:nvSpPr>
        <p:spPr>
          <a:xfrm>
            <a:off x="8069364" y="3333780"/>
            <a:ext cx="1036583" cy="230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05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Inhibitory path</a:t>
            </a:r>
            <a:endParaRPr sz="105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0" name="Google Shape;170;p16"/>
          <p:cNvSpPr txBox="1"/>
          <p:nvPr/>
        </p:nvSpPr>
        <p:spPr>
          <a:xfrm>
            <a:off x="73855" y="2173534"/>
            <a:ext cx="728151" cy="3000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5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ELL 1</a:t>
            </a:r>
            <a:endParaRPr sz="1500" b="1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1" name="Google Shape;171;p16"/>
          <p:cNvSpPr txBox="1"/>
          <p:nvPr/>
        </p:nvSpPr>
        <p:spPr>
          <a:xfrm>
            <a:off x="257949" y="5169265"/>
            <a:ext cx="638636" cy="3000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5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ELL 2</a:t>
            </a:r>
            <a:endParaRPr sz="1500" b="1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2" name="Google Shape;172;p16"/>
          <p:cNvSpPr txBox="1"/>
          <p:nvPr/>
        </p:nvSpPr>
        <p:spPr>
          <a:xfrm>
            <a:off x="7808962" y="2143499"/>
            <a:ext cx="798428" cy="3000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5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ELL 1</a:t>
            </a:r>
            <a:endParaRPr sz="1500" b="1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3" name="Google Shape;173;p16"/>
          <p:cNvSpPr txBox="1"/>
          <p:nvPr/>
        </p:nvSpPr>
        <p:spPr>
          <a:xfrm>
            <a:off x="7657303" y="5149677"/>
            <a:ext cx="695849" cy="3000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500" b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ELL 2</a:t>
            </a:r>
            <a:endParaRPr sz="1500" b="1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4" name="Google Shape;174;p16"/>
          <p:cNvSpPr/>
          <p:nvPr/>
        </p:nvSpPr>
        <p:spPr>
          <a:xfrm>
            <a:off x="6077259" y="4480685"/>
            <a:ext cx="171362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350" b="1">
                <a:solidFill>
                  <a:srgbClr val="124163"/>
                </a:solidFill>
                <a:latin typeface="Calibri"/>
                <a:ea typeface="Calibri"/>
                <a:cs typeface="Calibri"/>
                <a:sym typeface="Calibri"/>
              </a:rPr>
              <a:t>Voltage-independent</a:t>
            </a:r>
            <a:endParaRPr sz="1350" b="1">
              <a:solidFill>
                <a:srgbClr val="124163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5" name="Google Shape;175;p16"/>
          <p:cNvSpPr/>
          <p:nvPr/>
        </p:nvSpPr>
        <p:spPr>
          <a:xfrm>
            <a:off x="1977578" y="3115514"/>
            <a:ext cx="82096" cy="169557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6" name="Google Shape;176;p16"/>
          <p:cNvSpPr/>
          <p:nvPr/>
        </p:nvSpPr>
        <p:spPr>
          <a:xfrm>
            <a:off x="3144226" y="2471118"/>
            <a:ext cx="245403" cy="6257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7" name="Google Shape;177;p16"/>
          <p:cNvSpPr/>
          <p:nvPr/>
        </p:nvSpPr>
        <p:spPr>
          <a:xfrm rot="4255812">
            <a:off x="3527608" y="1859519"/>
            <a:ext cx="279800" cy="565386"/>
          </a:xfrm>
          <a:prstGeom prst="lightningBolt">
            <a:avLst/>
          </a:prstGeom>
          <a:solidFill>
            <a:srgbClr val="FFFF00"/>
          </a:solidFill>
          <a:ln w="25400" cap="flat" cmpd="sng">
            <a:solidFill>
              <a:srgbClr val="FFC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8" name="Google Shape;178;p16"/>
          <p:cNvSpPr txBox="1"/>
          <p:nvPr/>
        </p:nvSpPr>
        <p:spPr>
          <a:xfrm>
            <a:off x="1829670" y="2161286"/>
            <a:ext cx="70239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4000"/>
            </a:pPr>
            <a:r>
              <a:rPr lang="it-IT" sz="3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er</a:t>
            </a:r>
            <a:endParaRPr sz="3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9" name="Google Shape;179;p16"/>
          <p:cNvSpPr/>
          <p:nvPr/>
        </p:nvSpPr>
        <p:spPr>
          <a:xfrm>
            <a:off x="1936696" y="2589743"/>
            <a:ext cx="238642" cy="233962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16"/>
          <p:cNvSpPr txBox="1"/>
          <p:nvPr/>
        </p:nvSpPr>
        <p:spPr>
          <a:xfrm>
            <a:off x="5686900" y="2352662"/>
            <a:ext cx="70239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er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16"/>
          <p:cNvSpPr/>
          <p:nvPr/>
        </p:nvSpPr>
        <p:spPr>
          <a:xfrm rot="362147">
            <a:off x="5794410" y="2638035"/>
            <a:ext cx="71572" cy="20193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2" name="Google Shape;182;p16"/>
          <p:cNvSpPr/>
          <p:nvPr/>
        </p:nvSpPr>
        <p:spPr>
          <a:xfrm>
            <a:off x="5669535" y="3267533"/>
            <a:ext cx="262940" cy="415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3" name="Google Shape;183;p16"/>
          <p:cNvSpPr txBox="1"/>
          <p:nvPr/>
        </p:nvSpPr>
        <p:spPr>
          <a:xfrm>
            <a:off x="4032333" y="3538244"/>
            <a:ext cx="1761748" cy="346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GJ inhibition</a:t>
            </a:r>
            <a:endParaRPr b="1">
              <a:solidFill>
                <a:srgbClr val="FF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4" name="Google Shape;184;p16"/>
          <p:cNvSpPr txBox="1"/>
          <p:nvPr/>
        </p:nvSpPr>
        <p:spPr>
          <a:xfrm>
            <a:off x="2689877" y="2116685"/>
            <a:ext cx="52018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h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5" name="Google Shape;185;p16"/>
          <p:cNvSpPr/>
          <p:nvPr/>
        </p:nvSpPr>
        <p:spPr>
          <a:xfrm>
            <a:off x="3224365" y="2314100"/>
            <a:ext cx="82096" cy="169557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86" name="Google Shape;186;p16"/>
          <p:cNvSpPr/>
          <p:nvPr/>
        </p:nvSpPr>
        <p:spPr>
          <a:xfrm>
            <a:off x="3144748" y="2469367"/>
            <a:ext cx="245403" cy="6257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7" name="Google Shape;187;p16"/>
          <p:cNvSpPr/>
          <p:nvPr/>
        </p:nvSpPr>
        <p:spPr>
          <a:xfrm>
            <a:off x="1902533" y="3273523"/>
            <a:ext cx="245403" cy="6257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8" name="Google Shape;188;p16"/>
          <p:cNvSpPr/>
          <p:nvPr/>
        </p:nvSpPr>
        <p:spPr>
          <a:xfrm rot="2137997">
            <a:off x="2753652" y="3129222"/>
            <a:ext cx="55600" cy="295441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89" name="Google Shape;189;p16"/>
          <p:cNvCxnSpPr/>
          <p:nvPr/>
        </p:nvCxnSpPr>
        <p:spPr>
          <a:xfrm>
            <a:off x="2600845" y="3350393"/>
            <a:ext cx="151572" cy="114076"/>
          </a:xfrm>
          <a:prstGeom prst="straightConnector1">
            <a:avLst/>
          </a:prstGeom>
          <a:noFill/>
          <a:ln w="114300" cap="flat" cmpd="sng">
            <a:solidFill>
              <a:srgbClr val="16ABE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90" name="Google Shape;190;p16"/>
          <p:cNvCxnSpPr>
            <a:endCxn id="184" idx="1"/>
          </p:cNvCxnSpPr>
          <p:nvPr/>
        </p:nvCxnSpPr>
        <p:spPr>
          <a:xfrm rot="10800000" flipH="1">
            <a:off x="2476352" y="2255184"/>
            <a:ext cx="213525" cy="105075"/>
          </a:xfrm>
          <a:prstGeom prst="straightConnector1">
            <a:avLst/>
          </a:prstGeom>
          <a:noFill/>
          <a:ln w="9525" cap="flat" cmpd="sng">
            <a:solidFill>
              <a:srgbClr val="16ABE2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191" name="Google Shape;191;p16"/>
          <p:cNvCxnSpPr/>
          <p:nvPr/>
        </p:nvCxnSpPr>
        <p:spPr>
          <a:xfrm flipH="1">
            <a:off x="2473448" y="2310858"/>
            <a:ext cx="261792" cy="130995"/>
          </a:xfrm>
          <a:prstGeom prst="straightConnector1">
            <a:avLst/>
          </a:prstGeom>
          <a:noFill/>
          <a:ln w="9525" cap="flat" cmpd="sng">
            <a:solidFill>
              <a:srgbClr val="16ABE2"/>
            </a:solidFill>
            <a:prstDash val="solid"/>
            <a:round/>
            <a:headEnd type="none" w="sm" len="sm"/>
            <a:tailEnd type="triangle" w="med" len="med"/>
          </a:ln>
        </p:spPr>
      </p:cxnSp>
      <p:sp>
        <p:nvSpPr>
          <p:cNvPr id="192" name="Google Shape;192;p16"/>
          <p:cNvSpPr txBox="1"/>
          <p:nvPr/>
        </p:nvSpPr>
        <p:spPr>
          <a:xfrm>
            <a:off x="6433639" y="2912024"/>
            <a:ext cx="64571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1P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3" name="Google Shape;193;p16"/>
          <p:cNvSpPr/>
          <p:nvPr/>
        </p:nvSpPr>
        <p:spPr>
          <a:xfrm rot="-305100">
            <a:off x="6619957" y="2486682"/>
            <a:ext cx="67868" cy="442091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4" name="Google Shape;194;p16"/>
          <p:cNvSpPr txBox="1"/>
          <p:nvPr/>
        </p:nvSpPr>
        <p:spPr>
          <a:xfrm>
            <a:off x="6681205" y="2525631"/>
            <a:ext cx="70239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hK1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5" name="Google Shape;195;p16"/>
          <p:cNvSpPr/>
          <p:nvPr/>
        </p:nvSpPr>
        <p:spPr>
          <a:xfrm>
            <a:off x="6892342" y="2479099"/>
            <a:ext cx="245403" cy="6257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6" name="Google Shape;196;p16"/>
          <p:cNvSpPr txBox="1"/>
          <p:nvPr/>
        </p:nvSpPr>
        <p:spPr>
          <a:xfrm>
            <a:off x="6408381" y="2178335"/>
            <a:ext cx="52018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pPr>
              <a:buClr>
                <a:srgbClr val="000000"/>
              </a:buClr>
              <a:buSzPts val="2000"/>
            </a:pPr>
            <a:r>
              <a:rPr lang="it-IT" sz="15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h</a:t>
            </a:r>
            <a:endParaRPr sz="15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7" name="Google Shape;197;p16"/>
          <p:cNvSpPr/>
          <p:nvPr/>
        </p:nvSpPr>
        <p:spPr>
          <a:xfrm>
            <a:off x="6972481" y="2322080"/>
            <a:ext cx="82096" cy="169557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8" name="Google Shape;198;p16"/>
          <p:cNvSpPr/>
          <p:nvPr/>
        </p:nvSpPr>
        <p:spPr>
          <a:xfrm>
            <a:off x="6892864" y="2477348"/>
            <a:ext cx="245403" cy="6257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9" name="Google Shape;199;p16"/>
          <p:cNvSpPr/>
          <p:nvPr/>
        </p:nvSpPr>
        <p:spPr>
          <a:xfrm rot="2137997">
            <a:off x="6501768" y="3137203"/>
            <a:ext cx="55600" cy="295441"/>
          </a:xfrm>
          <a:prstGeom prst="rect">
            <a:avLst/>
          </a:prstGeom>
          <a:solidFill>
            <a:schemeClr val="accent1"/>
          </a:solidFill>
          <a:ln w="25400" cap="flat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200" name="Google Shape;200;p16"/>
          <p:cNvCxnSpPr/>
          <p:nvPr/>
        </p:nvCxnSpPr>
        <p:spPr>
          <a:xfrm>
            <a:off x="6348961" y="3358374"/>
            <a:ext cx="151572" cy="114076"/>
          </a:xfrm>
          <a:prstGeom prst="straightConnector1">
            <a:avLst/>
          </a:prstGeom>
          <a:noFill/>
          <a:ln w="114300" cap="flat" cmpd="sng">
            <a:solidFill>
              <a:srgbClr val="16ABE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201" name="Google Shape;201;p16"/>
          <p:cNvCxnSpPr>
            <a:endCxn id="196" idx="1"/>
          </p:cNvCxnSpPr>
          <p:nvPr/>
        </p:nvCxnSpPr>
        <p:spPr>
          <a:xfrm rot="10800000" flipH="1">
            <a:off x="6194856" y="2316834"/>
            <a:ext cx="213525" cy="105075"/>
          </a:xfrm>
          <a:prstGeom prst="straightConnector1">
            <a:avLst/>
          </a:prstGeom>
          <a:noFill/>
          <a:ln w="9525" cap="flat" cmpd="sng">
            <a:solidFill>
              <a:srgbClr val="16ABE2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202" name="Google Shape;202;p16"/>
          <p:cNvCxnSpPr/>
          <p:nvPr/>
        </p:nvCxnSpPr>
        <p:spPr>
          <a:xfrm flipH="1">
            <a:off x="6166651" y="2406000"/>
            <a:ext cx="261792" cy="130995"/>
          </a:xfrm>
          <a:prstGeom prst="straightConnector1">
            <a:avLst/>
          </a:prstGeom>
          <a:noFill/>
          <a:ln w="9525" cap="flat" cmpd="sng">
            <a:solidFill>
              <a:srgbClr val="16ABE2"/>
            </a:solidFill>
            <a:prstDash val="solid"/>
            <a:round/>
            <a:headEnd type="none" w="sm" len="sm"/>
            <a:tailEnd type="triangle" w="med" len="med"/>
          </a:ln>
        </p:spPr>
      </p:cxnSp>
      <p:sp>
        <p:nvSpPr>
          <p:cNvPr id="203" name="Google Shape;203;p16"/>
          <p:cNvSpPr/>
          <p:nvPr/>
        </p:nvSpPr>
        <p:spPr>
          <a:xfrm rot="5137413">
            <a:off x="7231471" y="2000401"/>
            <a:ext cx="319001" cy="481120"/>
          </a:xfrm>
          <a:prstGeom prst="lightningBolt">
            <a:avLst/>
          </a:prstGeom>
          <a:solidFill>
            <a:srgbClr val="FFFF00"/>
          </a:solidFill>
          <a:ln w="25400" cap="flat" cmpd="sng">
            <a:solidFill>
              <a:srgbClr val="FFC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/>
            <a:endParaRPr sz="105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04" name="Google Shape;204;p16"/>
          <p:cNvSpPr txBox="1"/>
          <p:nvPr/>
        </p:nvSpPr>
        <p:spPr>
          <a:xfrm>
            <a:off x="2303644" y="4022785"/>
            <a:ext cx="1657055" cy="4847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350" b="1">
                <a:solidFill>
                  <a:srgbClr val="124163"/>
                </a:solidFill>
                <a:latin typeface="Calibri"/>
                <a:ea typeface="Calibri"/>
                <a:cs typeface="Calibri"/>
                <a:sym typeface="Calibri"/>
              </a:rPr>
              <a:t>Voltage-dependent </a:t>
            </a:r>
            <a:endParaRPr sz="1350" b="1">
              <a:solidFill>
                <a:srgbClr val="124163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5" name="Google Shape;205;p16"/>
          <p:cNvSpPr/>
          <p:nvPr/>
        </p:nvSpPr>
        <p:spPr>
          <a:xfrm>
            <a:off x="2300355" y="4345454"/>
            <a:ext cx="171362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noAutofit/>
          </a:bodyPr>
          <a:lstStyle/>
          <a:p>
            <a:r>
              <a:rPr lang="it-IT" sz="1350" b="1">
                <a:solidFill>
                  <a:srgbClr val="124163"/>
                </a:solidFill>
                <a:latin typeface="Calibri"/>
                <a:ea typeface="Calibri"/>
                <a:cs typeface="Calibri"/>
                <a:sym typeface="Calibri"/>
              </a:rPr>
              <a:t>Voltage-independent</a:t>
            </a:r>
            <a:endParaRPr sz="1350" b="1">
              <a:solidFill>
                <a:srgbClr val="124163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6" name="Google Shape;206;p16"/>
          <p:cNvSpPr/>
          <p:nvPr/>
        </p:nvSpPr>
        <p:spPr>
          <a:xfrm rot="10800000" flipH="1">
            <a:off x="2176955" y="4391523"/>
            <a:ext cx="77513" cy="256841"/>
          </a:xfrm>
          <a:prstGeom prst="up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9050" cap="rnd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7" name="Google Shape;207;p16"/>
          <p:cNvSpPr/>
          <p:nvPr/>
        </p:nvSpPr>
        <p:spPr>
          <a:xfrm rot="10800000">
            <a:off x="5945797" y="4487935"/>
            <a:ext cx="179429" cy="238316"/>
          </a:xfrm>
          <a:prstGeom prst="up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9050" cap="rnd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8" name="Google Shape;208;p16"/>
          <p:cNvSpPr/>
          <p:nvPr/>
        </p:nvSpPr>
        <p:spPr>
          <a:xfrm rot="4860000">
            <a:off x="5940250" y="1968366"/>
            <a:ext cx="240255" cy="289607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9050" cap="rnd" cmpd="sng">
            <a:solidFill>
              <a:srgbClr val="147EA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69" tIns="34275" rIns="68569" bIns="34275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 sz="135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" name="Rettangolo 1"/>
          <p:cNvSpPr/>
          <p:nvPr/>
        </p:nvSpPr>
        <p:spPr>
          <a:xfrm rot="10800000" flipV="1">
            <a:off x="317920" y="6242931"/>
            <a:ext cx="796155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mplified scheme representing the short and long term regulation of GJ induced by PCB 153 and the SL pathways possibly involved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2574321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8</TotalTime>
  <Words>96</Words>
  <Application>Microsoft Office PowerPoint</Application>
  <PresentationFormat>Presentazione su schermo (4:3)</PresentationFormat>
  <Paragraphs>36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berta</dc:creator>
  <cp:lastModifiedBy>Elisabetta</cp:lastModifiedBy>
  <cp:revision>36</cp:revision>
  <dcterms:created xsi:type="dcterms:W3CDTF">2020-05-15T09:44:25Z</dcterms:created>
  <dcterms:modified xsi:type="dcterms:W3CDTF">2020-10-09T16:35:31Z</dcterms:modified>
</cp:coreProperties>
</file>